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  <p:sldId id="258" r:id="rId6"/>
    <p:sldId id="259" r:id="rId7"/>
    <p:sldId id="260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4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965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862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412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01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36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42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4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066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017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165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225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0211D-256F-4F72-85F1-71018EAB7996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FDE0F-D826-4DCA-9EF5-DA3B75F611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376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4265322" cy="1325563"/>
          </a:xfrm>
        </p:spPr>
        <p:txBody>
          <a:bodyPr>
            <a:normAutofit/>
          </a:bodyPr>
          <a:lstStyle/>
          <a:p>
            <a:r>
              <a:rPr lang="en-US" sz="2800" dirty="0"/>
              <a:t>Supplemental Figure </a:t>
            </a:r>
            <a:r>
              <a:rPr lang="en-US" sz="2800" dirty="0" smtClean="0"/>
              <a:t>1</a:t>
            </a:r>
            <a:endParaRPr lang="en-US" sz="28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9217" y="1690689"/>
            <a:ext cx="4874011" cy="3768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39304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5162" y="104230"/>
            <a:ext cx="4329717" cy="678062"/>
          </a:xfrm>
        </p:spPr>
        <p:txBody>
          <a:bodyPr>
            <a:noAutofit/>
          </a:bodyPr>
          <a:lstStyle/>
          <a:p>
            <a:r>
              <a:rPr lang="en-US" sz="2800" dirty="0"/>
              <a:t>Supplemental Figure </a:t>
            </a:r>
            <a:r>
              <a:rPr lang="en-US" sz="2800" dirty="0" smtClean="0"/>
              <a:t>2</a:t>
            </a:r>
            <a:endParaRPr lang="en-US" sz="28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7133" y="782292"/>
            <a:ext cx="6130344" cy="6075708"/>
          </a:xfrm>
        </p:spPr>
      </p:pic>
    </p:spTree>
    <p:extLst>
      <p:ext uri="{BB962C8B-B14F-4D97-AF65-F5344CB8AC3E}">
        <p14:creationId xmlns:p14="http://schemas.microsoft.com/office/powerpoint/2010/main" val="28338006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Supplemental Figure 3</a:t>
            </a:r>
            <a:endParaRPr lang="en-US" sz="28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839" y="1690689"/>
            <a:ext cx="6646293" cy="3928057"/>
          </a:xfrm>
        </p:spPr>
      </p:pic>
    </p:spTree>
    <p:extLst>
      <p:ext uri="{BB962C8B-B14F-4D97-AF65-F5344CB8AC3E}">
        <p14:creationId xmlns:p14="http://schemas.microsoft.com/office/powerpoint/2010/main" val="41606766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Supplemental Figure </a:t>
            </a:r>
            <a:r>
              <a:rPr lang="en-US" sz="2800" dirty="0" smtClean="0"/>
              <a:t>4</a:t>
            </a:r>
            <a:endParaRPr lang="en-US" sz="28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5463" y="1893431"/>
            <a:ext cx="6255435" cy="3554331"/>
          </a:xfrm>
        </p:spPr>
      </p:pic>
    </p:spTree>
    <p:extLst>
      <p:ext uri="{BB962C8B-B14F-4D97-AF65-F5344CB8AC3E}">
        <p14:creationId xmlns:p14="http://schemas.microsoft.com/office/powerpoint/2010/main" val="3715067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DD12495F2E65044BFCBD346A9E8E340" ma:contentTypeVersion="7" ma:contentTypeDescription="Create a new document." ma:contentTypeScope="" ma:versionID="1329f882d9c3a4515cb1cb01cb2207d7">
  <xsd:schema xmlns:xsd="http://www.w3.org/2001/XMLSchema" xmlns:p="http://schemas.microsoft.com/office/2006/metadata/properties" xmlns:ns2="f6c3e294-f48c-4abe-98d6-38ab9c3cec30" targetNamespace="http://schemas.microsoft.com/office/2006/metadata/properties" ma:root="true" ma:fieldsID="ba2afd302ba4d02a604e579e1cd15377" ns2:_="">
    <xsd:import namespace="f6c3e294-f48c-4abe-98d6-38ab9c3cec3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6c3e294-f48c-4abe-98d6-38ab9c3cec3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IsDeleted xmlns="f6c3e294-f48c-4abe-98d6-38ab9c3cec30">false</IsDeleted>
    <DocumentId xmlns="f6c3e294-f48c-4abe-98d6-38ab9c3cec30">Presentation 1.PPTX</DocumentId>
    <TitleName xmlns="f6c3e294-f48c-4abe-98d6-38ab9c3cec30">Presentation 1.PPTX</TitleName>
    <DocumentType xmlns="f6c3e294-f48c-4abe-98d6-38ab9c3cec30">Presentation</DocumentType>
    <StageName xmlns="f6c3e294-f48c-4abe-98d6-38ab9c3cec30" xsi:nil="true"/>
    <Checked_x0020_Out_x0020_To xmlns="f6c3e294-f48c-4abe-98d6-38ab9c3cec30">
      <UserInfo>
        <DisplayName/>
        <AccountId xsi:nil="true"/>
        <AccountType/>
      </UserInfo>
    </Checked_x0020_Out_x0020_To>
    <FileFormat xmlns="f6c3e294-f48c-4abe-98d6-38ab9c3cec30">PPTX</FileFormat>
  </documentManagement>
</p:properties>
</file>

<file path=customXml/itemProps1.xml><?xml version="1.0" encoding="utf-8"?>
<ds:datastoreItem xmlns:ds="http://schemas.openxmlformats.org/officeDocument/2006/customXml" ds:itemID="{171E801C-A5B9-469A-AB5A-2943071D836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494689C-F979-4299-A477-557DA64B54C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6c3e294-f48c-4abe-98d6-38ab9c3cec30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E7625019-76FE-4330-A417-517CEB770116}">
  <ds:schemaRefs>
    <ds:schemaRef ds:uri="http://purl.org/dc/elements/1.1/"/>
    <ds:schemaRef ds:uri="f6c3e294-f48c-4abe-98d6-38ab9c3cec30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12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l Figure 1</vt:lpstr>
      <vt:lpstr>Supplemental Figure 2</vt:lpstr>
      <vt:lpstr>Supplemental Figure 3</vt:lpstr>
      <vt:lpstr>Supplemental Figure 4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</dc:title>
  <dc:creator>Donyaye Computer</dc:creator>
  <cp:lastModifiedBy>FN-ADMIN</cp:lastModifiedBy>
  <cp:revision>2</cp:revision>
  <dcterms:created xsi:type="dcterms:W3CDTF">2017-06-04T10:49:23Z</dcterms:created>
  <dcterms:modified xsi:type="dcterms:W3CDTF">2017-06-25T19:56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DD12495F2E65044BFCBD346A9E8E340</vt:lpwstr>
  </property>
</Properties>
</file>